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4" r:id="rId2"/>
    <p:sldId id="278" r:id="rId3"/>
    <p:sldId id="295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owell, Jonathan (Agriculture, St. Lucia)" initials="pow167 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0769" autoAdjust="0"/>
  </p:normalViewPr>
  <p:slideViewPr>
    <p:cSldViewPr>
      <p:cViewPr>
        <p:scale>
          <a:sx n="100" d="100"/>
          <a:sy n="100" d="100"/>
        </p:scale>
        <p:origin x="1920" y="-19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DB7EA7-8FFB-416C-BB1E-53D2EF396F1D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C97600-E953-4022-8599-37EE6CC1F0F9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228085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1. Number of homoeolog triplets showing category two expression patterns under mock conditions then transitioning to category three expression patterns during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sarium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seudograminearum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fection. Predominantly expressed homoeologs under mock conditions tend to also be predominantly expressed during biotic stress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97600-E953-4022-8599-37EE6CC1F0F9}" type="slidenum">
              <a:rPr lang="en-AU" smtClean="0"/>
              <a:pPr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9712317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2. Differentially expressed biotic stress related genes observed globally according to biotic stress related gene ontologies. Counts show observed number of genes against/expected based on the background number of genes in the annotated reference. Defence genes (pathogenesis</a:t>
            </a:r>
            <a:r>
              <a:rPr lang="en-AU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lated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chitinases) and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ucine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ich repeat proteins were found to have disproportional contribution from subgenomes.</a:t>
            </a: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97600-E953-4022-8599-37EE6CC1F0F9}" type="slidenum">
              <a:rPr lang="en-AU" smtClean="0"/>
              <a:pPr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18641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Table 3. Homoeolog triplets with biotic stress related gene ontologies, displaying number of ‘A’, ‘B’ and ‘D’ homoeologs which were favoured by expression bias and induction bia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7C97600-E953-4022-8599-37EE6CC1F0F9}" type="slidenum">
              <a:rPr lang="en-AU" smtClean="0"/>
              <a:pPr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6577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1F173-DD42-46BD-BE55-030BEB56B026}" type="datetimeFigureOut">
              <a:rPr lang="en-AU" smtClean="0"/>
              <a:pPr/>
              <a:t>14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13D7C-0CC8-41EC-8343-C490BF0D4211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9260843"/>
              </p:ext>
            </p:extLst>
          </p:nvPr>
        </p:nvGraphicFramePr>
        <p:xfrm>
          <a:off x="2195736" y="764704"/>
          <a:ext cx="5168308" cy="198021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44518"/>
                <a:gridCol w="644518"/>
                <a:gridCol w="656680"/>
                <a:gridCol w="644518"/>
                <a:gridCol w="632358"/>
                <a:gridCol w="644518"/>
                <a:gridCol w="656680"/>
                <a:gridCol w="644518"/>
              </a:tblGrid>
              <a:tr h="28803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 smtClean="0">
                          <a:effectLst/>
                        </a:rPr>
                        <a:t>Fp (Cat 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8032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&gt;B&gt;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A&gt;D&gt;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B&gt;A&gt;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B&gt;D&gt;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&gt;A&gt;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D&gt;B&gt;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rowSpan="6"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 smtClean="0">
                          <a:effectLst/>
                        </a:rPr>
                        <a:t>Mock (Cat 2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vert="vert27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A&gt;B=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A&lt;B=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9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B </a:t>
                      </a:r>
                      <a:r>
                        <a:rPr lang="en-US" sz="1100" b="1" u="none" strike="noStrike" dirty="0" smtClean="0">
                          <a:effectLst/>
                        </a:rPr>
                        <a:t>&gt;A=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B </a:t>
                      </a:r>
                      <a:r>
                        <a:rPr lang="en-US" sz="1100" b="1" u="none" strike="noStrike" dirty="0" smtClean="0">
                          <a:effectLst/>
                        </a:rPr>
                        <a:t>&lt;A=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8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D&gt;A=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7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  <a:tr h="234026">
                <a:tc v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smtClean="0">
                          <a:effectLst/>
                        </a:rPr>
                        <a:t>D&lt;A=B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373184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181516"/>
              </p:ext>
            </p:extLst>
          </p:nvPr>
        </p:nvGraphicFramePr>
        <p:xfrm>
          <a:off x="827584" y="620688"/>
          <a:ext cx="7776864" cy="152932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599389"/>
                <a:gridCol w="741079"/>
                <a:gridCol w="827884"/>
                <a:gridCol w="864096"/>
                <a:gridCol w="936104"/>
                <a:gridCol w="946525"/>
                <a:gridCol w="758515"/>
                <a:gridCol w="1103272"/>
              </a:tblGrid>
              <a:tr h="128682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smtClean="0"/>
                        <a:t>Observed DE genes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smtClean="0"/>
                        <a:t>Expected DE genes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b="1" u="none" strike="noStrike" dirty="0" smtClean="0"/>
                        <a:t>Chi Squared Test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</a:tr>
              <a:tr h="249168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A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B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D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A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B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D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</a:tr>
              <a:tr h="151391"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smtClean="0"/>
                        <a:t>PR</a:t>
                      </a:r>
                      <a:r>
                        <a:rPr lang="en-AU" sz="1400" b="1" u="none" strike="noStrike" baseline="0" dirty="0" smtClean="0"/>
                        <a:t> and Chitinase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2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2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9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14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17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2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 smtClean="0"/>
                        <a:t>0.043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</a:tr>
              <a:tr h="151391"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err="1"/>
                        <a:t>Leucine</a:t>
                      </a:r>
                      <a:r>
                        <a:rPr lang="en-AU" sz="1400" b="1" u="none" strike="noStrike" dirty="0"/>
                        <a:t> Rich Repeat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7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31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7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25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21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 smtClean="0"/>
                        <a:t>0.013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</a:tr>
              <a:tr h="163038"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err="1"/>
                        <a:t>Peroxidase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8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21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7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14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18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13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</a:tr>
              <a:tr h="151391"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smtClean="0"/>
                        <a:t>PAL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4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3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/>
                        <a:t>6</a:t>
                      </a:r>
                      <a:endParaRPr lang="en-AU" sz="1200" b="1" i="0" u="none" strike="noStrike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</a:tr>
              <a:tr h="151391">
                <a:tc>
                  <a:txBody>
                    <a:bodyPr/>
                    <a:lstStyle/>
                    <a:p>
                      <a:pPr algn="ctr" fontAlgn="b"/>
                      <a:r>
                        <a:rPr lang="en-AU" sz="1400" b="1" u="none" strike="noStrike" dirty="0" smtClean="0"/>
                        <a:t>OPR</a:t>
                      </a:r>
                      <a:endParaRPr lang="en-AU" sz="1400" b="1" i="0" u="none" strike="noStrike" dirty="0">
                        <a:latin typeface="Arial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2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3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6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1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3.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200" u="none" strike="noStrike" dirty="0"/>
                        <a:t>6.5</a:t>
                      </a:r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en-AU" sz="1200" b="1" i="0" u="none" strike="noStrike" dirty="0">
                        <a:latin typeface="Arial"/>
                      </a:endParaRPr>
                    </a:p>
                  </a:txBody>
                  <a:tcPr marL="0" marR="0" marT="0" marB="0" anchor="ctr"/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8291536"/>
              </p:ext>
            </p:extLst>
          </p:nvPr>
        </p:nvGraphicFramePr>
        <p:xfrm>
          <a:off x="251520" y="2132858"/>
          <a:ext cx="8435279" cy="225495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296144"/>
                <a:gridCol w="792088"/>
                <a:gridCol w="864096"/>
                <a:gridCol w="869388"/>
                <a:gridCol w="921327"/>
                <a:gridCol w="921327"/>
                <a:gridCol w="921327"/>
                <a:gridCol w="921327"/>
                <a:gridCol w="928255"/>
              </a:tblGrid>
              <a:tr h="374745">
                <a:tc>
                  <a:txBody>
                    <a:bodyPr/>
                    <a:lstStyle/>
                    <a:p>
                      <a:pPr algn="l" fontAlgn="b"/>
                      <a:r>
                        <a:rPr lang="en-AU" sz="700" u="none" strike="noStrike" dirty="0">
                          <a:effectLst/>
                        </a:rPr>
                        <a:t> </a:t>
                      </a:r>
                      <a:endParaRPr lang="en-A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No Expression Bia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Express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A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Express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B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Express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D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No Induction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Bia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Induct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A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Express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B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Expression Bias </a:t>
                      </a:r>
                      <a:r>
                        <a:rPr lang="en-AU" sz="1000" b="1" u="none" strike="noStrike" dirty="0" smtClean="0">
                          <a:effectLst/>
                        </a:rPr>
                        <a:t/>
                      </a:r>
                      <a:br>
                        <a:rPr lang="en-AU" sz="1000" b="1" u="none" strike="noStrike" dirty="0" smtClean="0">
                          <a:effectLst/>
                        </a:rPr>
                      </a:br>
                      <a:r>
                        <a:rPr lang="en-AU" sz="1000" b="1" u="none" strike="noStrike" dirty="0" smtClean="0">
                          <a:effectLst/>
                        </a:rPr>
                        <a:t>Toward </a:t>
                      </a:r>
                      <a:r>
                        <a:rPr lang="en-AU" sz="1000" b="1" u="none" strike="noStrike" dirty="0">
                          <a:effectLst/>
                        </a:rPr>
                        <a:t>D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Disease Resistance Protein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2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Germin Protein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 smtClean="0">
                          <a:effectLst/>
                        </a:rPr>
                        <a:t>Leucine</a:t>
                      </a:r>
                      <a:r>
                        <a:rPr lang="en-AU" sz="1000" b="1" u="none" strike="noStrike" baseline="0" dirty="0" smtClean="0">
                          <a:effectLst/>
                        </a:rPr>
                        <a:t> Rich Repeat and Receptor Kinase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7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4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40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40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374745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Pathogenesis Related Protein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 smtClean="0">
                          <a:effectLst/>
                        </a:rPr>
                        <a:t>0</a:t>
                      </a:r>
                      <a:r>
                        <a:rPr lang="en-AU" sz="1000" u="none" strike="noStrike" dirty="0">
                          <a:effectLst/>
                        </a:rPr>
                        <a:t> 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 </a:t>
                      </a:r>
                      <a:r>
                        <a:rPr lang="en-AU" sz="1000" u="none" strike="noStrike" dirty="0" smtClean="0">
                          <a:effectLst/>
                        </a:rPr>
                        <a:t>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 </a:t>
                      </a:r>
                      <a:r>
                        <a:rPr lang="en-AU" sz="1000" u="none" strike="noStrike" dirty="0" smtClean="0">
                          <a:effectLst/>
                        </a:rPr>
                        <a:t>0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 </a:t>
                      </a:r>
                      <a:r>
                        <a:rPr lang="en-AU" sz="1000" u="none" strike="noStrike" dirty="0" smtClean="0">
                          <a:effectLst/>
                        </a:rPr>
                        <a:t>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ABC Transporter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18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2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3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3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Glutathione-S-transferase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3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  <a:tr h="191826"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b="1" u="none" strike="noStrike" dirty="0">
                          <a:effectLst/>
                        </a:rPr>
                        <a:t>Subtotals</a:t>
                      </a:r>
                      <a:endParaRPr lang="en-AU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14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>
                          <a:effectLst/>
                        </a:rPr>
                        <a:t>9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8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10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1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1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1000" u="none" strike="noStrike" dirty="0">
                          <a:effectLst/>
                        </a:rPr>
                        <a:t>2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95" marR="5195" marT="5195" marB="0" anchor="ctr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297</TotalTime>
  <Words>351</Words>
  <Application>Microsoft Office PowerPoint</Application>
  <PresentationFormat>On-screen Show (4:3)</PresentationFormat>
  <Paragraphs>17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CSI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owell, Jonathan (Agriculture, St. Lucia)</dc:creator>
  <cp:lastModifiedBy>Powell, Jonathan (Agriculture, St. Lucia)</cp:lastModifiedBy>
  <cp:revision>2861</cp:revision>
  <dcterms:created xsi:type="dcterms:W3CDTF">2014-11-03T04:48:04Z</dcterms:created>
  <dcterms:modified xsi:type="dcterms:W3CDTF">2016-07-14T00:09:56Z</dcterms:modified>
</cp:coreProperties>
</file>